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3107B4-3E46-41DB-8F34-4886115B9D1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6DD83B-9B9E-4C75-894F-A8B9AAFF20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678F3-5FDD-4EFF-8131-D15EB41095D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DED82B-A1FE-4D79-A6F8-7ADE5C4882C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402ABCA-3514-41F8-8E83-2706B78A86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654A937-12E0-456A-8813-DC8DE4A8ED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0259131-5A35-4F00-91AC-E95A68C423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624AF15-B231-41D1-B1C1-6A162FE70A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10BB9CA-E2ED-43F8-A763-4CF83C1308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A53AB0A-74AA-4894-813D-F24831621F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74040B5-B74C-419A-A593-167874D844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C7E68F-F687-4C69-873A-B85F697890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AEBA7FD-5510-4E48-91DE-C70A6D4278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202C69B-AC62-4B0D-8D36-72433AA238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335B31D-C55D-4D69-9D43-23AE04A09C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0C7EA2E-37E5-41E2-84B1-2BB0FFC9A8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E546410-18E0-4AEC-BAF7-E413FF20DCB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FC8573-D57C-4A53-A2A7-422D3B9A49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98E26-01F6-44D0-BEB1-40C1F30CA7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D4CF13-D5D4-4480-BDC3-9232D56437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E86957-659A-4A4F-8031-5432E8F6A4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D6971-D771-4EA8-974C-43A5CC34E0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F5C70A-9889-4A20-B08C-F3DF5A97B5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0D8274-BC08-4D7F-9F01-412DDFC3D7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01C3AE-CB23-481A-8B11-5F923BBCD04B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DB00C2B-87D1-422C-92FC-BE100F54087D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mailto:mrdu@fudan.edu.cn" TargetMode="External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文本框 5"/>
          <p:cNvSpPr/>
          <p:nvPr/>
        </p:nvSpPr>
        <p:spPr>
          <a:xfrm>
            <a:off x="743040" y="1268280"/>
            <a:ext cx="7777080" cy="123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Materials fo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vances and Challenges of Mesenchymal Stem Cells for Pregnancy Related Diseas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文本框 6"/>
          <p:cNvSpPr/>
          <p:nvPr/>
        </p:nvSpPr>
        <p:spPr>
          <a:xfrm>
            <a:off x="2050920" y="3198960"/>
            <a:ext cx="54864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The SM file includes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Table. S1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Pre-clinical trials evaluating MSC-EVs therapy for the treatment of 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文本框 8"/>
          <p:cNvSpPr/>
          <p:nvPr/>
        </p:nvSpPr>
        <p:spPr>
          <a:xfrm>
            <a:off x="3046320" y="2233440"/>
            <a:ext cx="3829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200000"/>
              </a:lnSpc>
              <a:spcAft>
                <a:spcPts val="45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Yan-Hong Li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,2*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Di-Zhang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,2,3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Mei-Rong Du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1,2,3,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†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文本框 10"/>
          <p:cNvSpPr/>
          <p:nvPr/>
        </p:nvSpPr>
        <p:spPr>
          <a:xfrm>
            <a:off x="2050920" y="2496960"/>
            <a:ext cx="5023080" cy="88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200000"/>
              </a:lnSpc>
              <a:spcAft>
                <a:spcPts val="45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rresponding author. to: Tel: +86-21-63455050; E-mail: </a:t>
            </a:r>
            <a:r>
              <a:rPr b="0" lang="en-US" sz="1200" spc="-1" strike="noStrike" u="sng">
                <a:solidFill>
                  <a:srgbClr val="0563c1"/>
                </a:solidFill>
                <a:uFillTx/>
                <a:latin typeface="Times New Roman"/>
                <a:ea typeface="Times New Roman"/>
                <a:hlinkClick r:id="rId1"/>
              </a:rPr>
              <a:t>mrdu@fudan.edu.c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200000"/>
              </a:lnSpc>
              <a:spcAft>
                <a:spcPts val="45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6" name=""/>
          <p:cNvGraphicFramePr/>
          <p:nvPr/>
        </p:nvGraphicFramePr>
        <p:xfrm>
          <a:off x="179280" y="676440"/>
          <a:ext cx="8856720" cy="2734920"/>
        </p:xfrm>
        <a:graphic>
          <a:graphicData uri="http://schemas.openxmlformats.org/drawingml/2006/table">
            <a:tbl>
              <a:tblPr/>
              <a:tblGrid>
                <a:gridCol w="603360"/>
                <a:gridCol w="411120"/>
                <a:gridCol w="981000"/>
                <a:gridCol w="662040"/>
                <a:gridCol w="2506680"/>
                <a:gridCol w="2600280"/>
                <a:gridCol w="1092240"/>
              </a:tblGrid>
              <a:tr h="379080"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SC sourc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V typ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ut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de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ffec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chanis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ud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2680"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ucMS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x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raperitonea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 ra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creased blood pressure and proteinuri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xosomal microRNA-139-5p accelerates trophoblast cell invasion and migr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iu, 2020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［</a:t>
                      </a:r>
                      <a:r>
                        <a:rPr b="0" lang="en-US" sz="900" spc="-1" strike="noStrike">
                          <a:solidFill>
                            <a:srgbClr val="0066ff"/>
                          </a:solidFill>
                          <a:latin typeface="Times New Roman"/>
                        </a:rPr>
                        <a:t>1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］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79440"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ucMS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x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raperitonea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 ra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creased blood pressure and proteinuria; increased number and quality of fetus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hibit cell apoptosis and promote angiogenesis in placental tissu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Xiong, 2018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［</a:t>
                      </a:r>
                      <a:r>
                        <a:rPr b="0" lang="en-US" sz="900" spc="-1" strike="noStrike">
                          <a:solidFill>
                            <a:srgbClr val="0066ff"/>
                          </a:solidFill>
                          <a:latin typeface="Times New Roman"/>
                        </a:rPr>
                        <a:t>2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］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15800"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ucMS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V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raperitonea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 ra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creased blood pressure and proteinuri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V-encapsulated miR-101 promotes proliferation and migration of placental trophoblast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ui, 2020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［</a:t>
                      </a:r>
                      <a:r>
                        <a:rPr b="0" lang="en-US" sz="900" spc="-1" strike="noStrike">
                          <a:solidFill>
                            <a:srgbClr val="0066ff"/>
                          </a:solidFill>
                          <a:latin typeface="Times New Roman"/>
                        </a:rPr>
                        <a:t>3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］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1240"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ucMS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Vs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bcutaneous injec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 ra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creased blood pressure and proteinuri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nhanced trophoblast proliferation and migr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ang, 2020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［</a:t>
                      </a:r>
                      <a:r>
                        <a:rPr b="0" lang="en-US" sz="900" spc="-1" strike="noStrike">
                          <a:solidFill>
                            <a:srgbClr val="0066ff"/>
                          </a:solidFill>
                          <a:latin typeface="Times New Roman"/>
                        </a:rPr>
                        <a:t>4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］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0880"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ucMS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x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raperitonea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E ra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ecreased blood pressure and proteinuria; increased weight of fetus and placent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uppress the contents of inflammatory factors and reduce cell apoptosis of placent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uang, 2021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［</a:t>
                      </a:r>
                      <a:r>
                        <a:rPr b="0" lang="en-US" sz="900" spc="-1" strike="noStrike">
                          <a:solidFill>
                            <a:srgbClr val="0066ff"/>
                          </a:solidFill>
                          <a:latin typeface="Times New Roman"/>
                        </a:rPr>
                        <a:t>5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］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15800"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ucMS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V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il ve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mox1-/- mou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hibition of fetal loss and fetal growth restriction; ameliorated spiral artery remodeli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rauterine immunomodul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6280" rIns="26280" tIns="12960" bIns="1296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glauer, 2021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［</a:t>
                      </a:r>
                      <a:r>
                        <a:rPr b="0" lang="en-US" sz="900" spc="-1" strike="noStrike">
                          <a:solidFill>
                            <a:srgbClr val="0066ff"/>
                          </a:solidFill>
                          <a:latin typeface="Times New Roman"/>
                        </a:rPr>
                        <a:t>6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］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6280" marR="26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87" name="文本框 2"/>
          <p:cNvSpPr/>
          <p:nvPr/>
        </p:nvSpPr>
        <p:spPr>
          <a:xfrm>
            <a:off x="108000" y="3924360"/>
            <a:ext cx="8785080" cy="2801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ts val="1397"/>
              </a:lnSpc>
              <a:spcAft>
                <a:spcPts val="45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ferences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ts val="1397"/>
              </a:lnSpc>
              <a:spcAft>
                <a:spcPts val="45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 Liu, H., Wang, F., Zhang, Y., Xing, Y. &amp; Wang, Q. Exosomal microRNA-139-5p from mesenchymal stem cells accelerates trophoblast cell invasion and migration by motivation of the ERK/MMP-2 pathway via downregulation  of protein tyrosine phosphatase.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 Obstet Gynaecol Res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2020)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ts val="1397"/>
              </a:lnSpc>
              <a:spcAft>
                <a:spcPts val="45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. Xiong, Z.H., Wei, J., Lu, M.Q., Jin, M.Y. &amp; Geng, H.L. Protective effect of human umbilical cord mesenchymal stem cell exosomes on preserving the morphology and angiogenesis of placenta in rats with preeclampsia.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iomed Pharmacother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5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1240-1247 (2018)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ts val="1397"/>
              </a:lnSpc>
              <a:spcAft>
                <a:spcPts val="45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. Cui, J.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et al.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iR-101-containing extracellular vesicles bind to BRD4 and enhance proliferation  and migration of trophoblasts in preeclampsia.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em Cell Res Ther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231 (2020)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ts val="1397"/>
              </a:lnSpc>
              <a:spcAft>
                <a:spcPts val="45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. Yang, Z.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et al.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Extracellular vesicle-derived microRNA-18b ameliorates preeclampsia by enhancing  trophoblast proliferation and migration via Notch2/TIM3/mTORC1 axis.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 Cell Mol Med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2021)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ts val="1397"/>
              </a:lnSpc>
              <a:spcAft>
                <a:spcPts val="45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. Huang, Q.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et al.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Human Umbilical Cord Mesenchymal Stem Cells-Derived Exosomal MicroRNA-18b-3p Inhibits the Occurrence of Preeclampsia by Targeting LEP.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noscale Res Lett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27 (2021)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ts val="1397"/>
              </a:lnSpc>
              <a:spcAft>
                <a:spcPts val="45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. Taglauer, E.S.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et al.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esenchymal stromal cell-derived extracellular vesicle therapy prevents preeclamptic physiology through intrauterine immunomodulationdagger.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iol Reprod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4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457-467 (2021)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ts val="1397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文本框 2"/>
          <p:cNvSpPr/>
          <p:nvPr/>
        </p:nvSpPr>
        <p:spPr>
          <a:xfrm>
            <a:off x="136080" y="316080"/>
            <a:ext cx="514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14440"/>
                <a:tab algn="l" pos="1028880"/>
                <a:tab algn="l" pos="1542960"/>
                <a:tab algn="l" pos="2057400"/>
                <a:tab algn="l" pos="2571840"/>
                <a:tab algn="l" pos="3086280"/>
                <a:tab algn="l" pos="3600360"/>
                <a:tab algn="l" pos="4114800"/>
                <a:tab algn="l" pos="4629240"/>
                <a:tab algn="l" pos="5143680"/>
                <a:tab algn="l" pos="5657760"/>
                <a:tab algn="l" pos="6172200"/>
                <a:tab algn="l" pos="6686640"/>
                <a:tab algn="l" pos="7201080"/>
                <a:tab algn="l" pos="7715160"/>
                <a:tab algn="l" pos="8229600"/>
                <a:tab algn="l" pos="8744040"/>
                <a:tab algn="l" pos="9258480"/>
                <a:tab algn="l" pos="9772560"/>
                <a:tab algn="l" pos="10287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Table S1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宋体"/>
              </a:rPr>
              <a:t>Pre-clinical trials evaluating MSC-EVs therapy for the treatment of 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文本框 3"/>
          <p:cNvSpPr/>
          <p:nvPr/>
        </p:nvSpPr>
        <p:spPr>
          <a:xfrm>
            <a:off x="108000" y="3427560"/>
            <a:ext cx="6985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hucMSCs, human umbilical cord blood-derived MSCs; Exo, exosome; EVs, extracellular vesicles; PE, preeclampsia.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06T01:30:27Z</dcterms:created>
  <dc:creator>Yan Hong Li</dc:creator>
  <dc:description/>
  <cp:keywords/>
  <dc:language>en-US</dc:language>
  <cp:lastModifiedBy>du mr</cp:lastModifiedBy>
  <dcterms:modified xsi:type="dcterms:W3CDTF">2021-05-12T04:45:04Z</dcterms:modified>
  <cp:revision>27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